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pct" ContentType="image/x-pict"/>
  <Override PartName="/ppt/media/image2.pct" ContentType="image/x-pi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F7B42B-F3D2-4AB3-957E-F95EBBF244F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DA8535-209E-4C86-978D-0185D0AA18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9F0519-1ECD-4345-AB21-8F985C99769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0E2E3C-9CE3-4089-8B00-646217F5825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70FEC8-5124-4A98-B0E3-813965B54A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5D04F7-323B-4BE1-B850-58DF97ADD1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827DB6-87A6-4F74-88F6-83395FFC3A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56C791-59E7-4DC3-A7CD-DB97A5EAAB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AA28BD-A888-4BF6-AE79-9E71F8B1AA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EE44D9-238F-489D-9BD7-9B1540ED27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472CA4-A2C5-480B-9845-CA093443FE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89F85F-A99B-4BA6-A738-C2AFAE2134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774268C-5187-41A9-BB83-A331E069AE5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ct"/><Relationship Id="rId3" Type="http://schemas.openxmlformats.org/officeDocument/2006/relationships/package" Target="../embeddings/oleObject2.xlsx"/><Relationship Id="rId4" Type="http://schemas.openxmlformats.org/officeDocument/2006/relationships/image" Target="../media/image2.pct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665280" y="4022640"/>
          <a:ext cx="5562360" cy="36622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65280" y="4022640"/>
                    <a:ext cx="5562360" cy="366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830160" y="395280"/>
          <a:ext cx="5315040" cy="337176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830160" y="395280"/>
                    <a:ext cx="5315040" cy="3371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" name=""/>
          <p:cNvSpPr/>
          <p:nvPr/>
        </p:nvSpPr>
        <p:spPr>
          <a:xfrm>
            <a:off x="2769480" y="3538440"/>
            <a:ext cx="136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Bit distanc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155680" y="7569360"/>
            <a:ext cx="268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Zs based on Bit distanc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rot="16200000">
            <a:off x="-436680" y="1714680"/>
            <a:ext cx="209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Euclidean distanc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rot="16200000">
            <a:off x="-744840" y="5484960"/>
            <a:ext cx="2667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Zs based on Euclid. dist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208960" y="838836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Supplementary Figur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534960" y="304920"/>
            <a:ext cx="48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534960" y="3886200"/>
            <a:ext cx="48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6-07T17:23:49Z</dcterms:created>
  <dc:creator>ucbcja0</dc:creator>
  <dc:description/>
  <dc:language>en-US</dc:language>
  <cp:lastModifiedBy>Corin Yeats</cp:lastModifiedBy>
  <dcterms:modified xsi:type="dcterms:W3CDTF">2007-07-04T12:52:54Z</dcterms:modified>
  <cp:revision>7</cp:revision>
  <dc:subject/>
  <dc:title>Slide 1</dc:title>
</cp:coreProperties>
</file>